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37AD8-50BF-44AD-88F8-12CC3641A3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FBC9A-0F43-4784-9B48-FFAAAF1E00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11620-33C0-4A2A-B0DA-5F1C3F4F90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6B786-942C-4EB9-889A-2E257CF20A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ABCA6-7655-44C6-889E-8962336601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99257-E20F-4EC3-84C9-0A7F8B71DB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15F84-A99E-464D-92E0-52A9BAE580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2EDAE-ED08-43C2-8BC4-0719F1454C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77261-AE7C-46F0-A40A-623E3E4670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47634-0B5D-40D4-86C9-8DEF20D816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B766F-BCCD-4779-8E4C-E4C193738D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30816-E43F-4F4F-836B-09D3EF4A6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D7F15A-233D-4359-ABE6-16C17D98306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36068" t="22062" r="29100" b="14080"/>
          <a:stretch/>
        </p:blipFill>
        <p:spPr>
          <a:xfrm>
            <a:off x="457200" y="762120"/>
            <a:ext cx="3048120" cy="41907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36068" t="22136" r="27361" b="50005"/>
          <a:stretch/>
        </p:blipFill>
        <p:spPr>
          <a:xfrm>
            <a:off x="457200" y="4952880"/>
            <a:ext cx="3200400" cy="1828800"/>
          </a:xfrm>
          <a:prstGeom prst="rect">
            <a:avLst/>
          </a:prstGeom>
          <a:ln w="0">
            <a:noFill/>
          </a:ln>
        </p:spPr>
      </p:pic>
      <p:sp>
        <p:nvSpPr>
          <p:cNvPr id="43" name="TextBox 7"/>
          <p:cNvSpPr/>
          <p:nvPr/>
        </p:nvSpPr>
        <p:spPr>
          <a:xfrm>
            <a:off x="152280" y="7238880"/>
            <a:ext cx="586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 Introgressed regions of seve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s are presented in IR64 backgrou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8T02:09:48Z</dcterms:created>
  <dc:creator>user1</dc:creator>
  <dc:description/>
  <dc:language>en-US</dc:language>
  <cp:lastModifiedBy>user1</cp:lastModifiedBy>
  <dcterms:modified xsi:type="dcterms:W3CDTF">2012-02-14T03:22:47Z</dcterms:modified>
  <cp:revision>7</cp:revision>
  <dc:subject/>
  <dc:title>Slide 1</dc:title>
</cp:coreProperties>
</file>